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01" r:id="rId2"/>
    <p:sldId id="302" r:id="rId3"/>
    <p:sldId id="303" r:id="rId4"/>
  </p:sldIdLst>
  <p:sldSz cx="12192000" cy="6858000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rash Memarnejadian" userId="b304fed9-e318-4d56-a6a3-510f35bed39c" providerId="ADAL" clId="{76A18783-6065-4AC6-98C4-C34A87CF3C56}"/>
    <pc:docChg chg="undo custSel addSld delSld modSld">
      <pc:chgData name="Arash Memarnejadian" userId="b304fed9-e318-4d56-a6a3-510f35bed39c" providerId="ADAL" clId="{76A18783-6065-4AC6-98C4-C34A87CF3C56}" dt="2024-04-11T14:23:04.082" v="3175" actId="1076"/>
      <pc:docMkLst>
        <pc:docMk/>
      </pc:docMkLst>
      <pc:sldChg chg="del">
        <pc:chgData name="Arash Memarnejadian" userId="b304fed9-e318-4d56-a6a3-510f35bed39c" providerId="ADAL" clId="{76A18783-6065-4AC6-98C4-C34A87CF3C56}" dt="2024-04-05T19:10:21.488" v="3139" actId="47"/>
        <pc:sldMkLst>
          <pc:docMk/>
          <pc:sldMk cId="588061640" sldId="257"/>
        </pc:sldMkLst>
      </pc:sldChg>
      <pc:sldChg chg="del">
        <pc:chgData name="Arash Memarnejadian" userId="b304fed9-e318-4d56-a6a3-510f35bed39c" providerId="ADAL" clId="{76A18783-6065-4AC6-98C4-C34A87CF3C56}" dt="2024-04-05T19:10:21.488" v="3139" actId="47"/>
        <pc:sldMkLst>
          <pc:docMk/>
          <pc:sldMk cId="207822340" sldId="292"/>
        </pc:sldMkLst>
      </pc:sldChg>
      <pc:sldChg chg="addSp modSp mod">
        <pc:chgData name="Arash Memarnejadian" userId="b304fed9-e318-4d56-a6a3-510f35bed39c" providerId="ADAL" clId="{76A18783-6065-4AC6-98C4-C34A87CF3C56}" dt="2024-04-05T14:44:12.810" v="3013" actId="20577"/>
        <pc:sldMkLst>
          <pc:docMk/>
          <pc:sldMk cId="2057963556" sldId="293"/>
        </pc:sldMkLst>
      </pc:sldChg>
      <pc:sldChg chg="del">
        <pc:chgData name="Arash Memarnejadian" userId="b304fed9-e318-4d56-a6a3-510f35bed39c" providerId="ADAL" clId="{76A18783-6065-4AC6-98C4-C34A87CF3C56}" dt="2024-04-05T19:10:21.488" v="3139" actId="47"/>
        <pc:sldMkLst>
          <pc:docMk/>
          <pc:sldMk cId="1906045133" sldId="294"/>
        </pc:sldMkLst>
      </pc:sldChg>
      <pc:sldChg chg="del">
        <pc:chgData name="Arash Memarnejadian" userId="b304fed9-e318-4d56-a6a3-510f35bed39c" providerId="ADAL" clId="{76A18783-6065-4AC6-98C4-C34A87CF3C56}" dt="2024-04-05T19:10:13.932" v="3138" actId="47"/>
        <pc:sldMkLst>
          <pc:docMk/>
          <pc:sldMk cId="3595978573" sldId="295"/>
        </pc:sldMkLst>
      </pc:sldChg>
      <pc:sldChg chg="del">
        <pc:chgData name="Arash Memarnejadian" userId="b304fed9-e318-4d56-a6a3-510f35bed39c" providerId="ADAL" clId="{76A18783-6065-4AC6-98C4-C34A87CF3C56}" dt="2024-04-05T19:10:21.488" v="3139" actId="47"/>
        <pc:sldMkLst>
          <pc:docMk/>
          <pc:sldMk cId="893519529" sldId="296"/>
        </pc:sldMkLst>
      </pc:sldChg>
      <pc:sldChg chg="addSp delSp modSp mod">
        <pc:chgData name="Arash Memarnejadian" userId="b304fed9-e318-4d56-a6a3-510f35bed39c" providerId="ADAL" clId="{76A18783-6065-4AC6-98C4-C34A87CF3C56}" dt="2024-04-05T15:15:21.635" v="3060" actId="20577"/>
        <pc:sldMkLst>
          <pc:docMk/>
          <pc:sldMk cId="1511035244" sldId="297"/>
        </pc:sldMkLst>
      </pc:sldChg>
      <pc:sldChg chg="addSp delSp modSp del mod">
        <pc:chgData name="Arash Memarnejadian" userId="b304fed9-e318-4d56-a6a3-510f35bed39c" providerId="ADAL" clId="{76A18783-6065-4AC6-98C4-C34A87CF3C56}" dt="2024-04-05T19:10:21.488" v="3139" actId="47"/>
        <pc:sldMkLst>
          <pc:docMk/>
          <pc:sldMk cId="2140466237" sldId="298"/>
        </pc:sldMkLst>
      </pc:sldChg>
      <pc:sldChg chg="addSp delSp modSp mod">
        <pc:chgData name="Arash Memarnejadian" userId="b304fed9-e318-4d56-a6a3-510f35bed39c" providerId="ADAL" clId="{76A18783-6065-4AC6-98C4-C34A87CF3C56}" dt="2024-04-05T14:53:10.054" v="3036" actId="20577"/>
        <pc:sldMkLst>
          <pc:docMk/>
          <pc:sldMk cId="929143605" sldId="299"/>
        </pc:sldMkLst>
      </pc:sldChg>
      <pc:sldChg chg="addSp delSp modSp mod">
        <pc:chgData name="Arash Memarnejadian" userId="b304fed9-e318-4d56-a6a3-510f35bed39c" providerId="ADAL" clId="{76A18783-6065-4AC6-98C4-C34A87CF3C56}" dt="2024-04-05T15:11:56.810" v="3047" actId="20577"/>
        <pc:sldMkLst>
          <pc:docMk/>
          <pc:sldMk cId="843035882" sldId="300"/>
        </pc:sldMkLst>
      </pc:sldChg>
      <pc:sldChg chg="addSp delSp modSp new mod">
        <pc:chgData name="Arash Memarnejadian" userId="b304fed9-e318-4d56-a6a3-510f35bed39c" providerId="ADAL" clId="{76A18783-6065-4AC6-98C4-C34A87CF3C56}" dt="2024-04-11T14:23:04.082" v="3175" actId="1076"/>
        <pc:sldMkLst>
          <pc:docMk/>
          <pc:sldMk cId="1345005426" sldId="301"/>
        </pc:sldMkLst>
      </pc:sldChg>
      <pc:sldChg chg="addSp delSp modSp new mod">
        <pc:chgData name="Arash Memarnejadian" userId="b304fed9-e318-4d56-a6a3-510f35bed39c" providerId="ADAL" clId="{76A18783-6065-4AC6-98C4-C34A87CF3C56}" dt="2024-04-11T14:21:47.582" v="3170"/>
        <pc:sldMkLst>
          <pc:docMk/>
          <pc:sldMk cId="3961700197" sldId="302"/>
        </pc:sldMkLst>
      </pc:sldChg>
      <pc:sldChg chg="addSp delSp modSp new mod">
        <pc:chgData name="Arash Memarnejadian" userId="b304fed9-e318-4d56-a6a3-510f35bed39c" providerId="ADAL" clId="{76A18783-6065-4AC6-98C4-C34A87CF3C56}" dt="2024-04-09T19:10:25.398" v="3166"/>
        <pc:sldMkLst>
          <pc:docMk/>
          <pc:sldMk cId="1870268675" sldId="303"/>
        </pc:sldMkLst>
      </pc:sldChg>
    </pc:docChg>
  </pc:docChgLst>
  <pc:docChgLst>
    <pc:chgData name="Arash Memarnejadian" userId="b304fed9-e318-4d56-a6a3-510f35bed39c" providerId="ADAL" clId="{BD653BB3-9918-425B-9CA1-7D1DBD19496C}"/>
    <pc:docChg chg="modSld">
      <pc:chgData name="Arash Memarnejadian" userId="b304fed9-e318-4d56-a6a3-510f35bed39c" providerId="ADAL" clId="{BD653BB3-9918-425B-9CA1-7D1DBD19496C}" dt="2025-07-28T15:48:49.083" v="2" actId="20577"/>
      <pc:docMkLst>
        <pc:docMk/>
      </pc:docMkLst>
      <pc:sldChg chg="modSp mod">
        <pc:chgData name="Arash Memarnejadian" userId="b304fed9-e318-4d56-a6a3-510f35bed39c" providerId="ADAL" clId="{BD653BB3-9918-425B-9CA1-7D1DBD19496C}" dt="2025-07-28T15:48:38.346" v="0" actId="20577"/>
        <pc:sldMkLst>
          <pc:docMk/>
          <pc:sldMk cId="1345005426" sldId="301"/>
        </pc:sldMkLst>
        <pc:spChg chg="mod">
          <ac:chgData name="Arash Memarnejadian" userId="b304fed9-e318-4d56-a6a3-510f35bed39c" providerId="ADAL" clId="{BD653BB3-9918-425B-9CA1-7D1DBD19496C}" dt="2025-07-28T15:48:38.346" v="0" actId="20577"/>
          <ac:spMkLst>
            <pc:docMk/>
            <pc:sldMk cId="1345005426" sldId="301"/>
            <ac:spMk id="2" creationId="{2006EAE2-B0E6-6A4E-EBC0-8BF60CE7495A}"/>
          </ac:spMkLst>
        </pc:spChg>
      </pc:sldChg>
      <pc:sldChg chg="modSp mod">
        <pc:chgData name="Arash Memarnejadian" userId="b304fed9-e318-4d56-a6a3-510f35bed39c" providerId="ADAL" clId="{BD653BB3-9918-425B-9CA1-7D1DBD19496C}" dt="2025-07-28T15:48:42.392" v="1" actId="20577"/>
        <pc:sldMkLst>
          <pc:docMk/>
          <pc:sldMk cId="3961700197" sldId="302"/>
        </pc:sldMkLst>
        <pc:spChg chg="mod">
          <ac:chgData name="Arash Memarnejadian" userId="b304fed9-e318-4d56-a6a3-510f35bed39c" providerId="ADAL" clId="{BD653BB3-9918-425B-9CA1-7D1DBD19496C}" dt="2025-07-28T15:48:42.392" v="1" actId="20577"/>
          <ac:spMkLst>
            <pc:docMk/>
            <pc:sldMk cId="3961700197" sldId="302"/>
            <ac:spMk id="3" creationId="{E9FE3F14-4D4F-0872-280C-6A5D305C6ABD}"/>
          </ac:spMkLst>
        </pc:spChg>
      </pc:sldChg>
      <pc:sldChg chg="modSp mod">
        <pc:chgData name="Arash Memarnejadian" userId="b304fed9-e318-4d56-a6a3-510f35bed39c" providerId="ADAL" clId="{BD653BB3-9918-425B-9CA1-7D1DBD19496C}" dt="2025-07-28T15:48:49.083" v="2" actId="20577"/>
        <pc:sldMkLst>
          <pc:docMk/>
          <pc:sldMk cId="1870268675" sldId="303"/>
        </pc:sldMkLst>
        <pc:spChg chg="mod">
          <ac:chgData name="Arash Memarnejadian" userId="b304fed9-e318-4d56-a6a3-510f35bed39c" providerId="ADAL" clId="{BD653BB3-9918-425B-9CA1-7D1DBD19496C}" dt="2025-07-28T15:48:49.083" v="2" actId="20577"/>
          <ac:spMkLst>
            <pc:docMk/>
            <pc:sldMk cId="1870268675" sldId="303"/>
            <ac:spMk id="2" creationId="{8DC6AA35-C297-7C08-5899-178E961DE8C8}"/>
          </ac:spMkLst>
        </pc:spChg>
      </pc:sldChg>
    </pc:docChg>
  </pc:docChgLst>
  <pc:docChgLst>
    <pc:chgData name="Arash Memarnejadian" userId="b304fed9-e318-4d56-a6a3-510f35bed39c" providerId="ADAL" clId="{4DEF3983-352C-4C7F-87E3-0DBEC72ED8A1}"/>
    <pc:docChg chg="custSel delSld modSld">
      <pc:chgData name="Arash Memarnejadian" userId="b304fed9-e318-4d56-a6a3-510f35bed39c" providerId="ADAL" clId="{4DEF3983-352C-4C7F-87E3-0DBEC72ED8A1}" dt="2025-06-04T21:47:52.969" v="104" actId="1076"/>
      <pc:docMkLst>
        <pc:docMk/>
      </pc:docMkLst>
      <pc:sldChg chg="del">
        <pc:chgData name="Arash Memarnejadian" userId="b304fed9-e318-4d56-a6a3-510f35bed39c" providerId="ADAL" clId="{4DEF3983-352C-4C7F-87E3-0DBEC72ED8A1}" dt="2025-06-04T21:44:11.184" v="0" actId="47"/>
        <pc:sldMkLst>
          <pc:docMk/>
          <pc:sldMk cId="2057963556" sldId="293"/>
        </pc:sldMkLst>
      </pc:sldChg>
      <pc:sldChg chg="del">
        <pc:chgData name="Arash Memarnejadian" userId="b304fed9-e318-4d56-a6a3-510f35bed39c" providerId="ADAL" clId="{4DEF3983-352C-4C7F-87E3-0DBEC72ED8A1}" dt="2025-06-04T21:44:11.184" v="0" actId="47"/>
        <pc:sldMkLst>
          <pc:docMk/>
          <pc:sldMk cId="1511035244" sldId="297"/>
        </pc:sldMkLst>
      </pc:sldChg>
      <pc:sldChg chg="delSp modSp mod">
        <pc:chgData name="Arash Memarnejadian" userId="b304fed9-e318-4d56-a6a3-510f35bed39c" providerId="ADAL" clId="{4DEF3983-352C-4C7F-87E3-0DBEC72ED8A1}" dt="2025-06-04T21:47:52.969" v="104" actId="1076"/>
        <pc:sldMkLst>
          <pc:docMk/>
          <pc:sldMk cId="1345005426" sldId="301"/>
        </pc:sldMkLst>
        <pc:spChg chg="mod">
          <ac:chgData name="Arash Memarnejadian" userId="b304fed9-e318-4d56-a6a3-510f35bed39c" providerId="ADAL" clId="{4DEF3983-352C-4C7F-87E3-0DBEC72ED8A1}" dt="2025-06-04T21:47:42.947" v="103" actId="20577"/>
          <ac:spMkLst>
            <pc:docMk/>
            <pc:sldMk cId="1345005426" sldId="301"/>
            <ac:spMk id="2" creationId="{2006EAE2-B0E6-6A4E-EBC0-8BF60CE7495A}"/>
          </ac:spMkLst>
        </pc:spChg>
        <pc:graphicFrameChg chg="mod">
          <ac:chgData name="Arash Memarnejadian" userId="b304fed9-e318-4d56-a6a3-510f35bed39c" providerId="ADAL" clId="{4DEF3983-352C-4C7F-87E3-0DBEC72ED8A1}" dt="2025-06-04T21:47:52.969" v="104" actId="1076"/>
          <ac:graphicFrameMkLst>
            <pc:docMk/>
            <pc:sldMk cId="1345005426" sldId="301"/>
            <ac:graphicFrameMk id="3" creationId="{545102F4-E2FC-FA30-61F9-5CF354CD3310}"/>
          </ac:graphicFrameMkLst>
        </pc:graphicFrameChg>
      </pc:sldChg>
      <pc:sldChg chg="modSp mod">
        <pc:chgData name="Arash Memarnejadian" userId="b304fed9-e318-4d56-a6a3-510f35bed39c" providerId="ADAL" clId="{4DEF3983-352C-4C7F-87E3-0DBEC72ED8A1}" dt="2025-06-04T21:47:31.368" v="78" actId="20577"/>
        <pc:sldMkLst>
          <pc:docMk/>
          <pc:sldMk cId="3961700197" sldId="302"/>
        </pc:sldMkLst>
        <pc:spChg chg="mod">
          <ac:chgData name="Arash Memarnejadian" userId="b304fed9-e318-4d56-a6a3-510f35bed39c" providerId="ADAL" clId="{4DEF3983-352C-4C7F-87E3-0DBEC72ED8A1}" dt="2025-06-04T21:47:31.368" v="78" actId="20577"/>
          <ac:spMkLst>
            <pc:docMk/>
            <pc:sldMk cId="3961700197" sldId="302"/>
            <ac:spMk id="3" creationId="{E9FE3F14-4D4F-0872-280C-6A5D305C6ABD}"/>
          </ac:spMkLst>
        </pc:spChg>
      </pc:sldChg>
      <pc:sldChg chg="modSp mod">
        <pc:chgData name="Arash Memarnejadian" userId="b304fed9-e318-4d56-a6a3-510f35bed39c" providerId="ADAL" clId="{4DEF3983-352C-4C7F-87E3-0DBEC72ED8A1}" dt="2025-06-04T21:47:09.877" v="31" actId="20577"/>
        <pc:sldMkLst>
          <pc:docMk/>
          <pc:sldMk cId="1870268675" sldId="303"/>
        </pc:sldMkLst>
        <pc:spChg chg="mod">
          <ac:chgData name="Arash Memarnejadian" userId="b304fed9-e318-4d56-a6a3-510f35bed39c" providerId="ADAL" clId="{4DEF3983-352C-4C7F-87E3-0DBEC72ED8A1}" dt="2025-06-04T21:47:09.877" v="31" actId="20577"/>
          <ac:spMkLst>
            <pc:docMk/>
            <pc:sldMk cId="1870268675" sldId="303"/>
            <ac:spMk id="2" creationId="{8DC6AA35-C297-7C08-5899-178E961DE8C8}"/>
          </ac:spMkLst>
        </pc:spChg>
      </pc:sldChg>
      <pc:sldChg chg="del">
        <pc:chgData name="Arash Memarnejadian" userId="b304fed9-e318-4d56-a6a3-510f35bed39c" providerId="ADAL" clId="{4DEF3983-352C-4C7F-87E3-0DBEC72ED8A1}" dt="2025-06-04T21:44:11.184" v="0" actId="47"/>
        <pc:sldMkLst>
          <pc:docMk/>
          <pc:sldMk cId="3887161208" sldId="304"/>
        </pc:sldMkLst>
      </pc:sldChg>
      <pc:sldChg chg="del">
        <pc:chgData name="Arash Memarnejadian" userId="b304fed9-e318-4d56-a6a3-510f35bed39c" providerId="ADAL" clId="{4DEF3983-352C-4C7F-87E3-0DBEC72ED8A1}" dt="2025-06-04T21:44:11.184" v="0" actId="47"/>
        <pc:sldMkLst>
          <pc:docMk/>
          <pc:sldMk cId="2018707891" sldId="305"/>
        </pc:sldMkLst>
      </pc:sldChg>
    </pc:docChg>
  </pc:docChgLst>
  <pc:docChgLst>
    <pc:chgData name="Arash Memarnejadian" userId="b304fed9-e318-4d56-a6a3-510f35bed39c" providerId="ADAL" clId="{CE436363-82F1-43D1-98D0-370332519030}"/>
    <pc:docChg chg="custSel modSld">
      <pc:chgData name="Arash Memarnejadian" userId="b304fed9-e318-4d56-a6a3-510f35bed39c" providerId="ADAL" clId="{CE436363-82F1-43D1-98D0-370332519030}" dt="2024-04-23T18:39:14.679" v="697" actId="13926"/>
      <pc:docMkLst>
        <pc:docMk/>
      </pc:docMkLst>
      <pc:sldChg chg="modSp mod">
        <pc:chgData name="Arash Memarnejadian" userId="b304fed9-e318-4d56-a6a3-510f35bed39c" providerId="ADAL" clId="{CE436363-82F1-43D1-98D0-370332519030}" dt="2024-04-23T18:39:14.679" v="697" actId="13926"/>
        <pc:sldMkLst>
          <pc:docMk/>
          <pc:sldMk cId="1511035244" sldId="297"/>
        </pc:sldMkLst>
      </pc:sldChg>
      <pc:sldChg chg="addSp modSp mod">
        <pc:chgData name="Arash Memarnejadian" userId="b304fed9-e318-4d56-a6a3-510f35bed39c" providerId="ADAL" clId="{CE436363-82F1-43D1-98D0-370332519030}" dt="2024-04-18T17:37:08.373" v="556" actId="20577"/>
        <pc:sldMkLst>
          <pc:docMk/>
          <pc:sldMk cId="1345005426" sldId="301"/>
        </pc:sldMkLst>
      </pc:sldChg>
    </pc:docChg>
  </pc:docChgLst>
  <pc:docChgLst>
    <pc:chgData name="Arash Memarnejadian" userId="b304fed9-e318-4d56-a6a3-510f35bed39c" providerId="ADAL" clId="{D8302B66-51F1-45A2-9A72-DF0D747A4F54}"/>
    <pc:docChg chg="undo custSel addSld delSld modSld modMainMaster modNotesMaster">
      <pc:chgData name="Arash Memarnejadian" userId="b304fed9-e318-4d56-a6a3-510f35bed39c" providerId="ADAL" clId="{D8302B66-51F1-45A2-9A72-DF0D747A4F54}" dt="2025-06-04T21:29:18.308" v="1623" actId="1076"/>
      <pc:docMkLst>
        <pc:docMk/>
      </pc:docMkLst>
      <pc:sldChg chg="addSp modSp add del mod">
        <pc:chgData name="Arash Memarnejadian" userId="b304fed9-e318-4d56-a6a3-510f35bed39c" providerId="ADAL" clId="{D8302B66-51F1-45A2-9A72-DF0D747A4F54}" dt="2025-06-03T16:07:10.823" v="367" actId="47"/>
        <pc:sldMkLst>
          <pc:docMk/>
          <pc:sldMk cId="3931888294" sldId="265"/>
        </pc:sldMkLst>
      </pc:sldChg>
      <pc:sldChg chg="modSp mod">
        <pc:chgData name="Arash Memarnejadian" userId="b304fed9-e318-4d56-a6a3-510f35bed39c" providerId="ADAL" clId="{D8302B66-51F1-45A2-9A72-DF0D747A4F54}" dt="2025-06-04T21:29:18.308" v="1623" actId="1076"/>
        <pc:sldMkLst>
          <pc:docMk/>
          <pc:sldMk cId="2057963556" sldId="293"/>
        </pc:sldMkLst>
      </pc:sldChg>
      <pc:sldChg chg="addSp modSp mod">
        <pc:chgData name="Arash Memarnejadian" userId="b304fed9-e318-4d56-a6a3-510f35bed39c" providerId="ADAL" clId="{D8302B66-51F1-45A2-9A72-DF0D747A4F54}" dt="2025-06-04T21:27:16.680" v="1620"/>
        <pc:sldMkLst>
          <pc:docMk/>
          <pc:sldMk cId="1511035244" sldId="297"/>
        </pc:sldMkLst>
      </pc:sldChg>
      <pc:sldChg chg="addSp delSp modSp del mod">
        <pc:chgData name="Arash Memarnejadian" userId="b304fed9-e318-4d56-a6a3-510f35bed39c" providerId="ADAL" clId="{D8302B66-51F1-45A2-9A72-DF0D747A4F54}" dt="2025-06-03T16:52:25.489" v="1314" actId="47"/>
        <pc:sldMkLst>
          <pc:docMk/>
          <pc:sldMk cId="929143605" sldId="299"/>
        </pc:sldMkLst>
      </pc:sldChg>
      <pc:sldChg chg="del">
        <pc:chgData name="Arash Memarnejadian" userId="b304fed9-e318-4d56-a6a3-510f35bed39c" providerId="ADAL" clId="{D8302B66-51F1-45A2-9A72-DF0D747A4F54}" dt="2025-06-03T16:44:44.543" v="1268" actId="47"/>
        <pc:sldMkLst>
          <pc:docMk/>
          <pc:sldMk cId="843035882" sldId="300"/>
        </pc:sldMkLst>
      </pc:sldChg>
      <pc:sldChg chg="modSp mod">
        <pc:chgData name="Arash Memarnejadian" userId="b304fed9-e318-4d56-a6a3-510f35bed39c" providerId="ADAL" clId="{D8302B66-51F1-45A2-9A72-DF0D747A4F54}" dt="2025-06-04T21:27:16.680" v="1620"/>
        <pc:sldMkLst>
          <pc:docMk/>
          <pc:sldMk cId="1345005426" sldId="301"/>
        </pc:sldMkLst>
        <pc:spChg chg="mod">
          <ac:chgData name="Arash Memarnejadian" userId="b304fed9-e318-4d56-a6a3-510f35bed39c" providerId="ADAL" clId="{D8302B66-51F1-45A2-9A72-DF0D747A4F54}" dt="2025-06-04T21:27:16.680" v="1620"/>
          <ac:spMkLst>
            <pc:docMk/>
            <pc:sldMk cId="1345005426" sldId="301"/>
            <ac:spMk id="2" creationId="{2006EAE2-B0E6-6A4E-EBC0-8BF60CE7495A}"/>
          </ac:spMkLst>
        </pc:spChg>
        <pc:graphicFrameChg chg="mod">
          <ac:chgData name="Arash Memarnejadian" userId="b304fed9-e318-4d56-a6a3-510f35bed39c" providerId="ADAL" clId="{D8302B66-51F1-45A2-9A72-DF0D747A4F54}" dt="2025-06-04T21:27:16.680" v="1620"/>
          <ac:graphicFrameMkLst>
            <pc:docMk/>
            <pc:sldMk cId="1345005426" sldId="301"/>
            <ac:graphicFrameMk id="3" creationId="{545102F4-E2FC-FA30-61F9-5CF354CD3310}"/>
          </ac:graphicFrameMkLst>
        </pc:graphicFrameChg>
      </pc:sldChg>
      <pc:sldChg chg="modSp mod">
        <pc:chgData name="Arash Memarnejadian" userId="b304fed9-e318-4d56-a6a3-510f35bed39c" providerId="ADAL" clId="{D8302B66-51F1-45A2-9A72-DF0D747A4F54}" dt="2025-06-04T21:27:16.680" v="1620"/>
        <pc:sldMkLst>
          <pc:docMk/>
          <pc:sldMk cId="3961700197" sldId="302"/>
        </pc:sldMkLst>
        <pc:spChg chg="mod">
          <ac:chgData name="Arash Memarnejadian" userId="b304fed9-e318-4d56-a6a3-510f35bed39c" providerId="ADAL" clId="{D8302B66-51F1-45A2-9A72-DF0D747A4F54}" dt="2025-06-04T21:27:16.680" v="1620"/>
          <ac:spMkLst>
            <pc:docMk/>
            <pc:sldMk cId="3961700197" sldId="302"/>
            <ac:spMk id="3" creationId="{E9FE3F14-4D4F-0872-280C-6A5D305C6ABD}"/>
          </ac:spMkLst>
        </pc:spChg>
        <pc:graphicFrameChg chg="mod">
          <ac:chgData name="Arash Memarnejadian" userId="b304fed9-e318-4d56-a6a3-510f35bed39c" providerId="ADAL" clId="{D8302B66-51F1-45A2-9A72-DF0D747A4F54}" dt="2025-06-04T21:27:16.680" v="1620"/>
          <ac:graphicFrameMkLst>
            <pc:docMk/>
            <pc:sldMk cId="3961700197" sldId="302"/>
            <ac:graphicFrameMk id="4" creationId="{378BE8B9-831C-88E5-2BFB-E3BBB9B7D2E5}"/>
          </ac:graphicFrameMkLst>
        </pc:graphicFrameChg>
      </pc:sldChg>
      <pc:sldChg chg="modSp mod">
        <pc:chgData name="Arash Memarnejadian" userId="b304fed9-e318-4d56-a6a3-510f35bed39c" providerId="ADAL" clId="{D8302B66-51F1-45A2-9A72-DF0D747A4F54}" dt="2025-06-04T21:27:16.680" v="1620"/>
        <pc:sldMkLst>
          <pc:docMk/>
          <pc:sldMk cId="1870268675" sldId="303"/>
        </pc:sldMkLst>
        <pc:spChg chg="mod">
          <ac:chgData name="Arash Memarnejadian" userId="b304fed9-e318-4d56-a6a3-510f35bed39c" providerId="ADAL" clId="{D8302B66-51F1-45A2-9A72-DF0D747A4F54}" dt="2025-06-04T21:27:16.680" v="1620"/>
          <ac:spMkLst>
            <pc:docMk/>
            <pc:sldMk cId="1870268675" sldId="303"/>
            <ac:spMk id="2" creationId="{8DC6AA35-C297-7C08-5899-178E961DE8C8}"/>
          </ac:spMkLst>
        </pc:spChg>
        <pc:graphicFrameChg chg="mod">
          <ac:chgData name="Arash Memarnejadian" userId="b304fed9-e318-4d56-a6a3-510f35bed39c" providerId="ADAL" clId="{D8302B66-51F1-45A2-9A72-DF0D747A4F54}" dt="2025-06-04T21:27:16.680" v="1620"/>
          <ac:graphicFrameMkLst>
            <pc:docMk/>
            <pc:sldMk cId="1870268675" sldId="303"/>
            <ac:graphicFrameMk id="6" creationId="{ACD0CEA4-0116-64AA-BED2-B6150BD803F7}"/>
          </ac:graphicFrameMkLst>
        </pc:graphicFrameChg>
      </pc:sldChg>
      <pc:sldChg chg="new del">
        <pc:chgData name="Arash Memarnejadian" userId="b304fed9-e318-4d56-a6a3-510f35bed39c" providerId="ADAL" clId="{D8302B66-51F1-45A2-9A72-DF0D747A4F54}" dt="2025-06-03T15:54:26.192" v="3" actId="47"/>
        <pc:sldMkLst>
          <pc:docMk/>
          <pc:sldMk cId="1079677253" sldId="304"/>
        </pc:sldMkLst>
      </pc:sldChg>
      <pc:sldChg chg="addSp delSp modSp add mod">
        <pc:chgData name="Arash Memarnejadian" userId="b304fed9-e318-4d56-a6a3-510f35bed39c" providerId="ADAL" clId="{D8302B66-51F1-45A2-9A72-DF0D747A4F54}" dt="2025-06-04T21:27:16.680" v="1620"/>
        <pc:sldMkLst>
          <pc:docMk/>
          <pc:sldMk cId="3887161208" sldId="304"/>
        </pc:sldMkLst>
      </pc:sldChg>
      <pc:sldChg chg="addSp delSp modSp new mod">
        <pc:chgData name="Arash Memarnejadian" userId="b304fed9-e318-4d56-a6a3-510f35bed39c" providerId="ADAL" clId="{D8302B66-51F1-45A2-9A72-DF0D747A4F54}" dt="2025-06-04T21:27:16.680" v="1620"/>
        <pc:sldMkLst>
          <pc:docMk/>
          <pc:sldMk cId="2018707891" sldId="305"/>
        </pc:sldMkLst>
      </pc:sldChg>
      <pc:sldMasterChg chg="modSp modSldLayout">
        <pc:chgData name="Arash Memarnejadian" userId="b304fed9-e318-4d56-a6a3-510f35bed39c" providerId="ADAL" clId="{D8302B66-51F1-45A2-9A72-DF0D747A4F54}" dt="2025-06-04T21:27:16.680" v="1620"/>
        <pc:sldMasterMkLst>
          <pc:docMk/>
          <pc:sldMasterMk cId="161919079" sldId="2147483648"/>
        </pc:sldMasterMkLst>
        <pc:spChg chg="mod">
          <ac:chgData name="Arash Memarnejadian" userId="b304fed9-e318-4d56-a6a3-510f35bed39c" providerId="ADAL" clId="{D8302B66-51F1-45A2-9A72-DF0D747A4F54}" dt="2025-06-04T21:27:16.680" v="1620"/>
          <ac:spMkLst>
            <pc:docMk/>
            <pc:sldMasterMk cId="161919079" sldId="2147483648"/>
            <ac:spMk id="2" creationId="{883D6775-B714-885E-3E30-DB5D320B6854}"/>
          </ac:spMkLst>
        </pc:spChg>
        <pc:spChg chg="mod">
          <ac:chgData name="Arash Memarnejadian" userId="b304fed9-e318-4d56-a6a3-510f35bed39c" providerId="ADAL" clId="{D8302B66-51F1-45A2-9A72-DF0D747A4F54}" dt="2025-06-04T21:27:16.680" v="1620"/>
          <ac:spMkLst>
            <pc:docMk/>
            <pc:sldMasterMk cId="161919079" sldId="2147483648"/>
            <ac:spMk id="3" creationId="{754FAB36-973B-ABD8-2688-F10AB20808C2}"/>
          </ac:spMkLst>
        </pc:spChg>
        <pc:spChg chg="mod">
          <ac:chgData name="Arash Memarnejadian" userId="b304fed9-e318-4d56-a6a3-510f35bed39c" providerId="ADAL" clId="{D8302B66-51F1-45A2-9A72-DF0D747A4F54}" dt="2025-06-04T21:27:16.680" v="1620"/>
          <ac:spMkLst>
            <pc:docMk/>
            <pc:sldMasterMk cId="161919079" sldId="2147483648"/>
            <ac:spMk id="4" creationId="{1F84F073-5A78-4199-5DF4-E9B2AFA4CB8B}"/>
          </ac:spMkLst>
        </pc:spChg>
        <pc:spChg chg="mod">
          <ac:chgData name="Arash Memarnejadian" userId="b304fed9-e318-4d56-a6a3-510f35bed39c" providerId="ADAL" clId="{D8302B66-51F1-45A2-9A72-DF0D747A4F54}" dt="2025-06-04T21:27:16.680" v="1620"/>
          <ac:spMkLst>
            <pc:docMk/>
            <pc:sldMasterMk cId="161919079" sldId="2147483648"/>
            <ac:spMk id="5" creationId="{8AC6ABEA-57C7-4A4C-12AA-49F9BF5188C7}"/>
          </ac:spMkLst>
        </pc:spChg>
        <pc:spChg chg="mod">
          <ac:chgData name="Arash Memarnejadian" userId="b304fed9-e318-4d56-a6a3-510f35bed39c" providerId="ADAL" clId="{D8302B66-51F1-45A2-9A72-DF0D747A4F54}" dt="2025-06-04T21:27:16.680" v="1620"/>
          <ac:spMkLst>
            <pc:docMk/>
            <pc:sldMasterMk cId="161919079" sldId="2147483648"/>
            <ac:spMk id="6" creationId="{0EA8FC68-FFFC-B972-2B58-A6A926DE8872}"/>
          </ac:spMkLst>
        </pc:spChg>
        <pc:sldLayoutChg chg="modSp">
          <pc:chgData name="Arash Memarnejadian" userId="b304fed9-e318-4d56-a6a3-510f35bed39c" providerId="ADAL" clId="{D8302B66-51F1-45A2-9A72-DF0D747A4F54}" dt="2025-06-04T21:27:16.680" v="1620"/>
          <pc:sldLayoutMkLst>
            <pc:docMk/>
            <pc:sldMasterMk cId="161919079" sldId="2147483648"/>
            <pc:sldLayoutMk cId="1905881018" sldId="2147483649"/>
          </pc:sldLayoutMkLst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1905881018" sldId="2147483649"/>
              <ac:spMk id="2" creationId="{57C3B284-1224-FF68-3B85-28A7C1C4E5A4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1905881018" sldId="2147483649"/>
              <ac:spMk id="3" creationId="{C03E1F61-F305-4545-5FD5-4AC2F2E5441E}"/>
            </ac:spMkLst>
          </pc:spChg>
        </pc:sldLayoutChg>
        <pc:sldLayoutChg chg="modSp">
          <pc:chgData name="Arash Memarnejadian" userId="b304fed9-e318-4d56-a6a3-510f35bed39c" providerId="ADAL" clId="{D8302B66-51F1-45A2-9A72-DF0D747A4F54}" dt="2025-06-04T21:27:16.680" v="1620"/>
          <pc:sldLayoutMkLst>
            <pc:docMk/>
            <pc:sldMasterMk cId="161919079" sldId="2147483648"/>
            <pc:sldLayoutMk cId="4062537110" sldId="2147483651"/>
          </pc:sldLayoutMkLst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4062537110" sldId="2147483651"/>
              <ac:spMk id="2" creationId="{AEBB4377-DA76-19AA-D7FC-230A2348B1A4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4062537110" sldId="2147483651"/>
              <ac:spMk id="3" creationId="{319FB7EA-0B83-58BC-19B0-F651A5A2499D}"/>
            </ac:spMkLst>
          </pc:spChg>
        </pc:sldLayoutChg>
        <pc:sldLayoutChg chg="modSp">
          <pc:chgData name="Arash Memarnejadian" userId="b304fed9-e318-4d56-a6a3-510f35bed39c" providerId="ADAL" clId="{D8302B66-51F1-45A2-9A72-DF0D747A4F54}" dt="2025-06-04T21:27:16.680" v="1620"/>
          <pc:sldLayoutMkLst>
            <pc:docMk/>
            <pc:sldMasterMk cId="161919079" sldId="2147483648"/>
            <pc:sldLayoutMk cId="2461146294" sldId="2147483652"/>
          </pc:sldLayoutMkLst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2461146294" sldId="2147483652"/>
              <ac:spMk id="3" creationId="{0E49CE21-FCD2-91B1-ADA2-5646371B45A1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2461146294" sldId="2147483652"/>
              <ac:spMk id="4" creationId="{7EABA1B5-37DF-D2EB-D646-B4EC126CA82D}"/>
            </ac:spMkLst>
          </pc:spChg>
        </pc:sldLayoutChg>
        <pc:sldLayoutChg chg="modSp">
          <pc:chgData name="Arash Memarnejadian" userId="b304fed9-e318-4d56-a6a3-510f35bed39c" providerId="ADAL" clId="{D8302B66-51F1-45A2-9A72-DF0D747A4F54}" dt="2025-06-04T21:27:16.680" v="1620"/>
          <pc:sldLayoutMkLst>
            <pc:docMk/>
            <pc:sldMasterMk cId="161919079" sldId="2147483648"/>
            <pc:sldLayoutMk cId="4055501658" sldId="2147483653"/>
          </pc:sldLayoutMkLst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4055501658" sldId="2147483653"/>
              <ac:spMk id="2" creationId="{C33575D4-F443-E7C2-82C3-293CF6A468CC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4055501658" sldId="2147483653"/>
              <ac:spMk id="3" creationId="{166FB626-AA73-32A5-811D-9C946139117B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4055501658" sldId="2147483653"/>
              <ac:spMk id="4" creationId="{22E4B493-516C-FDCC-17D5-26AD9B1F3C44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4055501658" sldId="2147483653"/>
              <ac:spMk id="5" creationId="{4F0198FA-29F6-3A91-0FF7-AF2ABABC03CE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4055501658" sldId="2147483653"/>
              <ac:spMk id="6" creationId="{A2C99939-FA56-1D8C-5035-C6002958CB40}"/>
            </ac:spMkLst>
          </pc:spChg>
        </pc:sldLayoutChg>
        <pc:sldLayoutChg chg="modSp">
          <pc:chgData name="Arash Memarnejadian" userId="b304fed9-e318-4d56-a6a3-510f35bed39c" providerId="ADAL" clId="{D8302B66-51F1-45A2-9A72-DF0D747A4F54}" dt="2025-06-04T21:27:16.680" v="1620"/>
          <pc:sldLayoutMkLst>
            <pc:docMk/>
            <pc:sldMasterMk cId="161919079" sldId="2147483648"/>
            <pc:sldLayoutMk cId="2937225366" sldId="2147483656"/>
          </pc:sldLayoutMkLst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2937225366" sldId="2147483656"/>
              <ac:spMk id="2" creationId="{389A6467-529F-3312-D77C-CB383CC3C865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2937225366" sldId="2147483656"/>
              <ac:spMk id="3" creationId="{6FC72766-C974-A2B6-9D1D-3C4D44C0E737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2937225366" sldId="2147483656"/>
              <ac:spMk id="4" creationId="{233F761F-AABF-E50C-C8E4-645FFD33F934}"/>
            </ac:spMkLst>
          </pc:spChg>
        </pc:sldLayoutChg>
        <pc:sldLayoutChg chg="modSp">
          <pc:chgData name="Arash Memarnejadian" userId="b304fed9-e318-4d56-a6a3-510f35bed39c" providerId="ADAL" clId="{D8302B66-51F1-45A2-9A72-DF0D747A4F54}" dt="2025-06-04T21:27:16.680" v="1620"/>
          <pc:sldLayoutMkLst>
            <pc:docMk/>
            <pc:sldMasterMk cId="161919079" sldId="2147483648"/>
            <pc:sldLayoutMk cId="607350290" sldId="2147483657"/>
          </pc:sldLayoutMkLst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607350290" sldId="2147483657"/>
              <ac:spMk id="2" creationId="{6D91787A-C79D-5CD9-41A5-DE72355EA812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607350290" sldId="2147483657"/>
              <ac:spMk id="3" creationId="{94F82616-809F-EA06-BB3B-AE9D96F08732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607350290" sldId="2147483657"/>
              <ac:spMk id="4" creationId="{5445DBAD-D654-EB3D-ADC5-76C3EB3C37C4}"/>
            </ac:spMkLst>
          </pc:spChg>
        </pc:sldLayoutChg>
        <pc:sldLayoutChg chg="modSp">
          <pc:chgData name="Arash Memarnejadian" userId="b304fed9-e318-4d56-a6a3-510f35bed39c" providerId="ADAL" clId="{D8302B66-51F1-45A2-9A72-DF0D747A4F54}" dt="2025-06-04T21:27:16.680" v="1620"/>
          <pc:sldLayoutMkLst>
            <pc:docMk/>
            <pc:sldMasterMk cId="161919079" sldId="2147483648"/>
            <pc:sldLayoutMk cId="1179073896" sldId="2147483659"/>
          </pc:sldLayoutMkLst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1179073896" sldId="2147483659"/>
              <ac:spMk id="2" creationId="{8C955973-BE05-DE8B-76B2-EEE6D785B1C2}"/>
            </ac:spMkLst>
          </pc:spChg>
          <pc:spChg chg="mod">
            <ac:chgData name="Arash Memarnejadian" userId="b304fed9-e318-4d56-a6a3-510f35bed39c" providerId="ADAL" clId="{D8302B66-51F1-45A2-9A72-DF0D747A4F54}" dt="2025-06-04T21:27:16.680" v="1620"/>
            <ac:spMkLst>
              <pc:docMk/>
              <pc:sldMasterMk cId="161919079" sldId="2147483648"/>
              <pc:sldLayoutMk cId="1179073896" sldId="2147483659"/>
              <ac:spMk id="3" creationId="{504D5EFF-59C7-9A7B-E54B-1441A33BCEC9}"/>
            </ac:spMkLst>
          </pc:spChg>
        </pc:sldLayoutChg>
      </pc:sldMasterChg>
    </pc:docChg>
  </pc:docChgLst>
  <pc:docChgLst>
    <pc:chgData name="Arash Memarnejadian" userId="b304fed9-e318-4d56-a6a3-510f35bed39c" providerId="ADAL" clId="{B2B57558-D777-4233-BCFE-2E58F9751A2A}"/>
    <pc:docChg chg="undo custSel modSld modNotesMaster">
      <pc:chgData name="Arash Memarnejadian" userId="b304fed9-e318-4d56-a6a3-510f35bed39c" providerId="ADAL" clId="{B2B57558-D777-4233-BCFE-2E58F9751A2A}" dt="2024-02-20T19:01:50.357" v="444" actId="20577"/>
      <pc:docMkLst>
        <pc:docMk/>
      </pc:docMkLst>
      <pc:sldChg chg="modSp mod">
        <pc:chgData name="Arash Memarnejadian" userId="b304fed9-e318-4d56-a6a3-510f35bed39c" providerId="ADAL" clId="{B2B57558-D777-4233-BCFE-2E58F9751A2A}" dt="2024-02-20T15:29:54.059" v="253" actId="1036"/>
        <pc:sldMkLst>
          <pc:docMk/>
          <pc:sldMk cId="207822340" sldId="292"/>
        </pc:sldMkLst>
      </pc:sldChg>
      <pc:sldChg chg="addSp delSp modSp mod">
        <pc:chgData name="Arash Memarnejadian" userId="b304fed9-e318-4d56-a6a3-510f35bed39c" providerId="ADAL" clId="{B2B57558-D777-4233-BCFE-2E58F9751A2A}" dt="2024-02-20T15:31:11.042" v="264" actId="1076"/>
        <pc:sldMkLst>
          <pc:docMk/>
          <pc:sldMk cId="2057963556" sldId="293"/>
        </pc:sldMkLst>
      </pc:sldChg>
      <pc:sldChg chg="addSp modSp mod">
        <pc:chgData name="Arash Memarnejadian" userId="b304fed9-e318-4d56-a6a3-510f35bed39c" providerId="ADAL" clId="{B2B57558-D777-4233-BCFE-2E58F9751A2A}" dt="2024-02-20T19:01:50.357" v="444" actId="20577"/>
        <pc:sldMkLst>
          <pc:docMk/>
          <pc:sldMk cId="1511035244" sldId="297"/>
        </pc:sldMkLst>
      </pc:sldChg>
      <pc:sldChg chg="addSp delSp modSp mod">
        <pc:chgData name="Arash Memarnejadian" userId="b304fed9-e318-4d56-a6a3-510f35bed39c" providerId="ADAL" clId="{B2B57558-D777-4233-BCFE-2E58F9751A2A}" dt="2024-02-20T15:49:42.523" v="413" actId="164"/>
        <pc:sldMkLst>
          <pc:docMk/>
          <pc:sldMk cId="929143605" sldId="29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337AD166-70BD-45C1-A170-95BB277726D7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9138" y="1163638"/>
            <a:ext cx="558482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FF41CB4D-7DAB-431B-B038-091530ABD0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510536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C3B284-1224-FF68-3B85-28A7C1C4E5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03E1F61-F305-4545-5FD5-4AC2F2E544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2A4410-4904-6025-5220-CC0DFF7EC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37DAF4-B521-0911-5CAF-B99BE1342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0D1272-40DE-E0E7-7A38-512CE951F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05881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D0746-3355-395F-B94A-D1EB81E9AC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38E16C-1197-45E4-C063-474647E20E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5393E7-09B5-280C-B42B-62BDBCB0A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B9F174-967B-7043-458B-BF8B649AB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1839FF-E9B5-FAB4-498C-51E05E09B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72640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C955973-BE05-DE8B-76B2-EEE6D785B1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4D5EFF-59C7-9A7B-E54B-1441A33BCE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51EF26-41CA-9346-D4E3-8ACFC64E80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3684C-6932-A563-99E3-4960E3825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680B0D-EB14-F291-DD49-1001B972CE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79073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FB3A75-E736-CF52-12BE-7841210355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30B4D0-25F4-0F27-1888-24AB397448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FAA487-7A30-1458-93BB-442C07501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C97556-9841-D5C2-730B-3BD5FF54A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8AC26F-AF3D-665E-348E-A35DC15F1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61962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BB4377-DA76-19AA-D7FC-230A2348B1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9FB7EA-0B83-58BC-19B0-F651A5A249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45926C-7008-8307-D49B-6D1183A84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C3BB42-D0E0-BDA2-2195-710EB1BCC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0E23DE-7E4A-D56E-1F3A-2B8F2427E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62537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18E8B-943B-72A9-8D1C-7F95705934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49CE21-FCD2-91B1-ADA2-5646371B45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ABA1B5-37DF-D2EB-D646-B4EC126CA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332EF3-8FD3-16C3-CE20-28B585C54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4E7F45-6BEA-DE9C-4DAD-4A3469C78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BD1DBB-93FD-67EC-2002-09740DF5F4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61146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575D4-F443-E7C2-82C3-293CF6A468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6FB626-AA73-32A5-811D-9C94613911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E4B493-516C-FDCC-17D5-26AD9B1F3C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0198FA-29F6-3A91-0FF7-AF2ABABC03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C99939-FA56-1D8C-5035-C6002958CB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7682689-1D37-735C-AF8D-23B6C3D99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8BFF2F-F82B-FDD6-DDE7-DD0DB11D42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A4CCFB-B9F3-4EDF-5ADC-A6FD127FD3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55501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94C265-712D-FECE-AEC9-C31EBAEBF3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B4D295-1289-5FE0-6AAA-287B467FE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B261A8-83A8-785D-CA13-9D4408574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9ED6A50-73DB-2CF4-367A-DC8D0EB5D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40596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4D3F31C-AFF5-464F-E913-EEB5ABF2D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39F860-928F-1A3B-2678-3091E7D68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25F49E-C4BA-C9F1-A20B-AB0CA6126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32968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9A6467-529F-3312-D77C-CB383CC3C8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C72766-C974-A2B6-9D1D-3C4D44C0E7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3F761F-AABF-E50C-C8E4-645FFD33F9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E4C45E-54BA-4BC3-D6F2-9714971E8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D81443-A80F-C37E-C3B6-258E7A7F0F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8FBC54-6F6C-1DA8-C485-D3CC71401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37225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91787A-C79D-5CD9-41A5-DE72355EA8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F82616-809F-EA06-BB3B-AE9D96F087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45DBAD-D654-EB3D-ADC5-76C3EB3C37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331517-4A1B-411A-A561-8484E39DF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BBBB92-39C0-BA07-0ABD-FE95BD934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917BEB-E63E-6E43-114A-6A4D9CDF4F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07350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83D6775-B714-885E-3E30-DB5D320B68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4FAB36-973B-ABD8-2688-F10AB20808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84F073-5A78-4199-5DF4-E9B2AFA4CB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9666EE-3A7B-445F-B778-136F35695764}" type="datetimeFigureOut">
              <a:rPr lang="en-CA" smtClean="0"/>
              <a:t>2025-07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C6ABEA-57C7-4A4C-12AA-49F9BF5188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A8FC68-FFFC-B972-2B58-A6A926DE88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FD154A-9642-4AED-8FB3-3738F6B2AB1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919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006EAE2-B0E6-6A4E-EBC0-8BF60CE7495A}"/>
              </a:ext>
            </a:extLst>
          </p:cNvPr>
          <p:cNvSpPr txBox="1"/>
          <p:nvPr/>
        </p:nvSpPr>
        <p:spPr>
          <a:xfrm>
            <a:off x="86265" y="88091"/>
            <a:ext cx="4894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 – Hematology Parameters</a:t>
            </a:r>
            <a:endParaRPr lang="en-CA" dirty="0">
              <a:highlight>
                <a:srgbClr val="FFFF00"/>
              </a:highlight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45102F4-E2FC-FA30-61F9-5CF354CD33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8644207"/>
              </p:ext>
            </p:extLst>
          </p:nvPr>
        </p:nvGraphicFramePr>
        <p:xfrm>
          <a:off x="1640034" y="457423"/>
          <a:ext cx="8386096" cy="60763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9164374" imgH="6639800" progId="Prism10.Document">
                  <p:embed/>
                </p:oleObj>
              </mc:Choice>
              <mc:Fallback>
                <p:oleObj name="Prism 10" r:id="rId2" imgW="9164374" imgH="6639800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45102F4-E2FC-FA30-61F9-5CF354CD33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40034" y="457423"/>
                        <a:ext cx="8386096" cy="60763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450054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9FE3F14-4D4F-0872-280C-6A5D305C6ABD}"/>
              </a:ext>
            </a:extLst>
          </p:cNvPr>
          <p:cNvSpPr txBox="1"/>
          <p:nvPr/>
        </p:nvSpPr>
        <p:spPr>
          <a:xfrm>
            <a:off x="138023" y="127556"/>
            <a:ext cx="5813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 – Calcium and Kidney Function Tests</a:t>
            </a:r>
            <a:endParaRPr lang="en-CA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78BE8B9-831C-88E5-2BFB-E3BBB9B7D2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8399915"/>
              </p:ext>
            </p:extLst>
          </p:nvPr>
        </p:nvGraphicFramePr>
        <p:xfrm>
          <a:off x="1533525" y="496888"/>
          <a:ext cx="9126539" cy="5862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9126199" imgH="5862227" progId="Prism10.Document">
                  <p:embed/>
                </p:oleObj>
              </mc:Choice>
              <mc:Fallback>
                <p:oleObj name="Prism 10" r:id="rId2" imgW="9126199" imgH="5862227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378BE8B9-831C-88E5-2BFB-E3BBB9B7D2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33525" y="496888"/>
                        <a:ext cx="9126539" cy="5862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617001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DC6AA35-C297-7C08-5899-178E961DE8C8}"/>
              </a:ext>
            </a:extLst>
          </p:cNvPr>
          <p:cNvSpPr txBox="1"/>
          <p:nvPr/>
        </p:nvSpPr>
        <p:spPr>
          <a:xfrm>
            <a:off x="155277" y="64571"/>
            <a:ext cx="4475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</a:t>
            </a:r>
            <a:r>
              <a:rPr lang="en-US"/>
              <a:t>Figure 2 </a:t>
            </a:r>
            <a:r>
              <a:rPr lang="en-US" dirty="0"/>
              <a:t>– Liver Function Tests</a:t>
            </a:r>
            <a:endParaRPr lang="en-CA" dirty="0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ACD0CEA4-0116-64AA-BED2-B6150BD803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0465236"/>
              </p:ext>
            </p:extLst>
          </p:nvPr>
        </p:nvGraphicFramePr>
        <p:xfrm>
          <a:off x="1487489" y="249239"/>
          <a:ext cx="9217025" cy="6359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9216233" imgH="6359240" progId="Prism10.Document">
                  <p:embed/>
                </p:oleObj>
              </mc:Choice>
              <mc:Fallback>
                <p:oleObj name="Prism 10" r:id="rId2" imgW="9216233" imgH="6359240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ACD0CEA4-0116-64AA-BED2-B6150BD803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87489" y="249239"/>
                        <a:ext cx="9217025" cy="6359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70268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34</TotalTime>
  <Words>22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10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sh Memarnejadian</dc:creator>
  <cp:lastModifiedBy>Arash Memarnejadian</cp:lastModifiedBy>
  <cp:revision>40</cp:revision>
  <cp:lastPrinted>2024-02-20T17:49:05Z</cp:lastPrinted>
  <dcterms:created xsi:type="dcterms:W3CDTF">2023-06-19T17:55:01Z</dcterms:created>
  <dcterms:modified xsi:type="dcterms:W3CDTF">2025-07-28T15:48:50Z</dcterms:modified>
</cp:coreProperties>
</file>